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2.jpeg" ContentType="image/jpeg"/>
  <Override PartName="/ppt/media/image1.jpeg" ContentType="image/jpeg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08062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6784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97916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780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6784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97916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01760"/>
            <a:ext cx="6803640" cy="7802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fr-FR" sz="5870" spc="-1" strike="noStrike">
                <a:latin typeface="Arial"/>
              </a:rPr>
              <a:t>Click to edit the title text format</a:t>
            </a:r>
            <a:endParaRPr b="0" lang="fr-FR" sz="587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Aft>
                <a:spcPts val="1888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4270" spc="-1" strike="noStrike">
                <a:latin typeface="Arial"/>
              </a:rPr>
              <a:t>Click to edit the outline text format</a:t>
            </a:r>
            <a:endParaRPr b="0" lang="fr-FR" sz="4270" spc="-1" strike="noStrike">
              <a:latin typeface="Arial"/>
            </a:endParaRPr>
          </a:p>
          <a:p>
            <a:pPr lvl="1" marL="864000" indent="-324000">
              <a:spcAft>
                <a:spcPts val="1511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3730" spc="-1" strike="noStrike">
                <a:latin typeface="Arial"/>
              </a:rPr>
              <a:t>Second Outline Level</a:t>
            </a:r>
            <a:endParaRPr b="0" lang="fr-FR" sz="3730" spc="-1" strike="noStrike">
              <a:latin typeface="Arial"/>
            </a:endParaRPr>
          </a:p>
          <a:p>
            <a:pPr lvl="2" marL="1296000" indent="-288000">
              <a:spcAft>
                <a:spcPts val="1134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3200" spc="-1" strike="noStrike">
                <a:latin typeface="Arial"/>
              </a:rPr>
              <a:t>Third Outline Level</a:t>
            </a:r>
            <a:endParaRPr b="0" lang="fr-FR" sz="3200" spc="-1" strike="noStrike">
              <a:latin typeface="Arial"/>
            </a:endParaRPr>
          </a:p>
          <a:p>
            <a:pPr lvl="3" marL="1728000" indent="-216000">
              <a:spcAft>
                <a:spcPts val="754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670" spc="-1" strike="noStrike">
                <a:latin typeface="Arial"/>
              </a:rPr>
              <a:t>Fourth Outline Level</a:t>
            </a:r>
            <a:endParaRPr b="0" lang="fr-FR" sz="2670" spc="-1" strike="noStrike">
              <a:latin typeface="Arial"/>
            </a:endParaRPr>
          </a:p>
          <a:p>
            <a:pPr lvl="4" marL="2160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Fifth Outline Level</a:t>
            </a:r>
            <a:endParaRPr b="0" lang="fr-FR" sz="2670" spc="-1" strike="noStrike">
              <a:latin typeface="Arial"/>
            </a:endParaRPr>
          </a:p>
          <a:p>
            <a:pPr lvl="5" marL="2592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ixth Outline Level</a:t>
            </a:r>
            <a:endParaRPr b="0" lang="fr-FR" sz="2670" spc="-1" strike="noStrike">
              <a:latin typeface="Arial"/>
            </a:endParaRPr>
          </a:p>
          <a:p>
            <a:pPr lvl="6" marL="3024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eventh Outline Level</a:t>
            </a:r>
            <a:endParaRPr b="0" lang="fr-FR" sz="2670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7800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585520" y="9182880"/>
            <a:ext cx="2396160" cy="69516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42052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pPr algn="r"/>
            <a:fld id="{EE2C7B50-FB48-4A86-838C-C549CFD0F6F4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Shape 1"/>
          <p:cNvSpPr txBox="1"/>
          <p:nvPr/>
        </p:nvSpPr>
        <p:spPr>
          <a:xfrm>
            <a:off x="720000" y="6955200"/>
            <a:ext cx="6048000" cy="56880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1" lang="fr-FR" sz="1000" spc="-1" strike="noStrike">
                <a:latin typeface="Arial"/>
                <a:ea typeface="Droid Sans Fallback"/>
              </a:rPr>
              <a:t>Suppl Figure S2: Recombinant cICDH and cICDH-C363S.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A total of 5 µg of each protein, with or without 10 mM DTT was subjected to SDS-polyacrylamide gel electrophoresis on a 10%  gel. The separated protein bands were stained with Coomassie Blue.</a:t>
            </a:r>
            <a:endParaRPr b="0" lang="fr-FR" sz="1000" spc="-1" strike="noStrike">
              <a:latin typeface="Arial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2160000" y="3096000"/>
            <a:ext cx="3295080" cy="3313440"/>
            <a:chOff x="2160000" y="3096000"/>
            <a:chExt cx="3295080" cy="3313440"/>
          </a:xfrm>
        </p:grpSpPr>
        <p:sp>
          <p:nvSpPr>
            <p:cNvPr id="43" name="CustomShape 3"/>
            <p:cNvSpPr/>
            <p:nvPr/>
          </p:nvSpPr>
          <p:spPr>
            <a:xfrm>
              <a:off x="4699080" y="4263840"/>
              <a:ext cx="756000" cy="34596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0"/>
                  </a:lnTo>
                  <a:lnTo>
                    <a:pt x="21600" y="21600"/>
                  </a:lnTo>
                  <a:lnTo>
                    <a:pt x="0" y="21600"/>
                  </a:lnTo>
                  <a:lnTo>
                    <a:pt x="0" y="0"/>
                  </a:lnTo>
                  <a:close/>
                </a:path>
              </a:pathLst>
            </a:cu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8680" bIns="45000"/>
            <a:p>
              <a:pPr>
                <a:lnSpc>
                  <a:spcPct val="94000"/>
                </a:lnSpc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ICDH</a:t>
              </a:r>
              <a:endParaRPr b="0" lang="fr-FR" sz="1200" spc="-1" strike="noStrike">
                <a:latin typeface="Arial"/>
              </a:endParaRPr>
            </a:p>
            <a:p>
              <a:pPr>
                <a:lnSpc>
                  <a:spcPct val="94000"/>
                </a:lnSpc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(~48 kDa)</a:t>
              </a:r>
              <a:endParaRPr b="0" lang="fr-FR" sz="1200" spc="-1" strike="noStrike"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1"/>
            <a:srcRect l="56580" t="4471" r="20452" b="16669"/>
            <a:stretch/>
          </p:blipFill>
          <p:spPr>
            <a:xfrm>
              <a:off x="2719080" y="3388680"/>
              <a:ext cx="1007640" cy="2216160"/>
            </a:xfrm>
            <a:prstGeom prst="rect">
              <a:avLst/>
            </a:prstGeom>
            <a:ln>
              <a:noFill/>
            </a:ln>
          </p:spPr>
        </p:pic>
        <p:sp>
          <p:nvSpPr>
            <p:cNvPr id="45" name="CustomShape 4"/>
            <p:cNvSpPr/>
            <p:nvPr/>
          </p:nvSpPr>
          <p:spPr>
            <a:xfrm>
              <a:off x="3886200" y="3096000"/>
              <a:ext cx="68544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 DTT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6" name="CustomShape 5"/>
            <p:cNvSpPr/>
            <p:nvPr/>
          </p:nvSpPr>
          <p:spPr>
            <a:xfrm rot="16200000">
              <a:off x="2606400" y="5886720"/>
              <a:ext cx="7416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ICDH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7" name="CustomShape 6"/>
            <p:cNvSpPr/>
            <p:nvPr/>
          </p:nvSpPr>
          <p:spPr>
            <a:xfrm rot="16200000">
              <a:off x="3000960" y="5672160"/>
              <a:ext cx="957600" cy="5166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ICDH</a:t>
              </a:r>
              <a:endParaRPr b="0" lang="fr-FR" sz="1400" spc="-1" strike="noStrike">
                <a:latin typeface="Arial"/>
              </a:endParaRPr>
            </a:p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363S</a:t>
              </a:r>
              <a:endParaRPr b="0" lang="fr-FR" sz="1400" spc="-1" strike="noStrike"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2"/>
            <a:srcRect l="2778" t="4471" r="77827" b="16669"/>
            <a:stretch/>
          </p:blipFill>
          <p:spPr>
            <a:xfrm>
              <a:off x="3811680" y="3388680"/>
              <a:ext cx="851040" cy="2216160"/>
            </a:xfrm>
            <a:prstGeom prst="rect">
              <a:avLst/>
            </a:prstGeom>
            <a:ln>
              <a:noFill/>
            </a:ln>
          </p:spPr>
        </p:pic>
        <p:sp>
          <p:nvSpPr>
            <p:cNvPr id="49" name="CustomShape 7"/>
            <p:cNvSpPr/>
            <p:nvPr/>
          </p:nvSpPr>
          <p:spPr>
            <a:xfrm rot="16200000">
              <a:off x="3578400" y="5886720"/>
              <a:ext cx="7416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ICDH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0" name="CustomShape 8"/>
            <p:cNvSpPr/>
            <p:nvPr/>
          </p:nvSpPr>
          <p:spPr>
            <a:xfrm rot="16200000">
              <a:off x="3972960" y="5672160"/>
              <a:ext cx="957600" cy="5166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ICDH</a:t>
              </a:r>
              <a:endParaRPr b="0" lang="fr-FR" sz="1400" spc="-1" strike="noStrike">
                <a:latin typeface="Arial"/>
              </a:endParaRPr>
            </a:p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C363S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1" name="CustomShape 9"/>
            <p:cNvSpPr/>
            <p:nvPr/>
          </p:nvSpPr>
          <p:spPr>
            <a:xfrm>
              <a:off x="2892240" y="3096000"/>
              <a:ext cx="72936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 DTT</a:t>
              </a:r>
              <a:endParaRPr b="0" lang="fr-FR" sz="1400" spc="-1" strike="noStrike">
                <a:latin typeface="Arial"/>
              </a:endParaRPr>
            </a:p>
          </p:txBody>
        </p:sp>
        <p:grpSp>
          <p:nvGrpSpPr>
            <p:cNvPr id="52" name="Group 10"/>
            <p:cNvGrpSpPr/>
            <p:nvPr/>
          </p:nvGrpSpPr>
          <p:grpSpPr>
            <a:xfrm>
              <a:off x="2160000" y="3496680"/>
              <a:ext cx="518760" cy="1784880"/>
              <a:chOff x="2160000" y="3496680"/>
              <a:chExt cx="518760" cy="1784880"/>
            </a:xfrm>
          </p:grpSpPr>
          <p:sp>
            <p:nvSpPr>
              <p:cNvPr id="53" name="TextShape 11"/>
              <p:cNvSpPr txBox="1"/>
              <p:nvPr/>
            </p:nvSpPr>
            <p:spPr>
              <a:xfrm>
                <a:off x="2251080" y="4047840"/>
                <a:ext cx="35136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70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54" name="Line 12"/>
              <p:cNvSpPr/>
              <p:nvPr/>
            </p:nvSpPr>
            <p:spPr>
              <a:xfrm>
                <a:off x="2584080" y="416808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55" name="TextShape 13"/>
              <p:cNvSpPr txBox="1"/>
              <p:nvPr/>
            </p:nvSpPr>
            <p:spPr>
              <a:xfrm>
                <a:off x="2160000" y="3832200"/>
                <a:ext cx="43668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100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56" name="Line 14"/>
              <p:cNvSpPr/>
              <p:nvPr/>
            </p:nvSpPr>
            <p:spPr>
              <a:xfrm>
                <a:off x="2588760" y="395244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57" name="TextShape 15"/>
              <p:cNvSpPr txBox="1"/>
              <p:nvPr/>
            </p:nvSpPr>
            <p:spPr>
              <a:xfrm>
                <a:off x="2164680" y="3652560"/>
                <a:ext cx="43668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130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58" name="Line 16"/>
              <p:cNvSpPr/>
              <p:nvPr/>
            </p:nvSpPr>
            <p:spPr>
              <a:xfrm>
                <a:off x="2593440" y="377280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59" name="TextShape 17"/>
              <p:cNvSpPr txBox="1"/>
              <p:nvPr/>
            </p:nvSpPr>
            <p:spPr>
              <a:xfrm>
                <a:off x="2169360" y="3496680"/>
                <a:ext cx="43668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250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60" name="Line 18"/>
              <p:cNvSpPr/>
              <p:nvPr/>
            </p:nvSpPr>
            <p:spPr>
              <a:xfrm>
                <a:off x="2598120" y="361692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61" name="TextShape 19"/>
              <p:cNvSpPr txBox="1"/>
              <p:nvPr/>
            </p:nvSpPr>
            <p:spPr>
              <a:xfrm>
                <a:off x="2255760" y="4234320"/>
                <a:ext cx="35136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55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62" name="Line 20"/>
              <p:cNvSpPr/>
              <p:nvPr/>
            </p:nvSpPr>
            <p:spPr>
              <a:xfrm>
                <a:off x="2588760" y="435456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63" name="TextShape 21"/>
              <p:cNvSpPr txBox="1"/>
              <p:nvPr/>
            </p:nvSpPr>
            <p:spPr>
              <a:xfrm>
                <a:off x="2255760" y="4696200"/>
                <a:ext cx="35136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35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64" name="Line 22"/>
              <p:cNvSpPr/>
              <p:nvPr/>
            </p:nvSpPr>
            <p:spPr>
              <a:xfrm>
                <a:off x="2588760" y="481644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  <p:sp>
            <p:nvSpPr>
              <p:cNvPr id="65" name="TextShape 23"/>
              <p:cNvSpPr txBox="1"/>
              <p:nvPr/>
            </p:nvSpPr>
            <p:spPr>
              <a:xfrm>
                <a:off x="2260440" y="5020560"/>
                <a:ext cx="351360" cy="2610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lIns="90000" rIns="90000" tIns="45000" bIns="45000"/>
              <a:p>
                <a:r>
                  <a:rPr b="0" lang="fr-FR" sz="1200" spc="-1" strike="noStrike">
                    <a:latin typeface="Arial"/>
                  </a:rPr>
                  <a:t>25</a:t>
                </a:r>
                <a:endParaRPr b="0" lang="fr-FR" sz="1200" spc="-1" strike="noStrike">
                  <a:latin typeface="Arial"/>
                </a:endParaRPr>
              </a:p>
            </p:txBody>
          </p:sp>
          <p:sp>
            <p:nvSpPr>
              <p:cNvPr id="66" name="Line 24"/>
              <p:cNvSpPr/>
              <p:nvPr/>
            </p:nvSpPr>
            <p:spPr>
              <a:xfrm>
                <a:off x="2593440" y="5140800"/>
                <a:ext cx="80640" cy="0"/>
              </a:xfrm>
              <a:prstGeom prst="line">
                <a:avLst/>
              </a:prstGeom>
              <a:ln w="18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</p:sp>
        </p:grp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</TotalTime>
  <Application>LibreOffice/6.0.6.2$Linux_X86_64 LibreOffice_project/00m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0T12:55:51Z</dcterms:created>
  <dc:creator>JP </dc:creator>
  <dc:description/>
  <dc:language>fr-FR</dc:language>
  <cp:lastModifiedBy>JP </cp:lastModifiedBy>
  <dcterms:modified xsi:type="dcterms:W3CDTF">2018-11-21T09:59:52Z</dcterms:modified>
  <cp:revision>17</cp:revision>
  <dc:subject/>
  <dc:title/>
</cp:coreProperties>
</file>